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8" autoAdjust="0"/>
    <p:restoredTop sz="88132" autoAdjust="0"/>
  </p:normalViewPr>
  <p:slideViewPr>
    <p:cSldViewPr snapToGrid="0">
      <p:cViewPr varScale="1">
        <p:scale>
          <a:sx n="58" d="100"/>
          <a:sy n="58" d="100"/>
        </p:scale>
        <p:origin x="7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5E66913-A1ED-4A92-B2CF-125D9BFF4C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A861C431-D396-4DF0-B41F-AAC8076A67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948D964-9A50-4997-A2E5-AA3B5181B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473608F-0E0D-4EFE-B620-A22A26A2E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BCCE25B-9DEF-42EC-8686-78EC9D214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8522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05EAE62-2A14-462F-8EBB-3EE959C856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0008DB2-A356-4EDE-A198-0BCDCEFA54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A4DC0D0-A5EF-4626-9868-B8D14F2EF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EBFA7CF-8C7C-4BD4-B128-54CA92E64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CE41580-849E-4933-AC30-7403CAC4E3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7614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CE2A7B5-9B69-43CA-A73B-A15C616886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937FC06-1031-452B-B2B3-BC8C35D747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F7E659E-BC02-4112-A4AB-C9BA118AE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A7295B6-E0EF-400C-8F57-2A2D36C79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73741BE-26F3-492D-93E6-B5E85ABAB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036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D3353EE-8C0C-411A-8CF6-3AF1B76019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255D53B-DF05-467E-97B2-3AE92111BA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9686B03-CB3F-4D75-9301-ECFDDEFF3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D895ACA-4D6F-44F6-A973-AF3E2E549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2322C98-AEAD-415E-AB9C-3189741E3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55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8461A25-6B1F-4DD4-A6EA-08216140E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CFCF35C-485F-43BC-9FC0-D5D9BAEF61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A2FCEFD-E255-4147-8F69-DB2C6886D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76B43E5-1607-4750-AFE7-323B972E1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E1AD822-52A4-403E-BE76-3974AC080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7065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8AEDF00-9C10-49D6-9C7D-2B85410AE3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3D21E55-C094-4659-90B6-055FF15954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A71AFD9-149F-4F3B-A5BC-D3EF10CE6F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1FF4FF1-54CB-419D-ADF9-BFE606523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FC4ED51-EF05-48EC-B293-4216E3B6F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9EB3639-4E08-4C1E-8BDA-1913800B3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035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33D5030-D7CA-4894-86DC-C2915C679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01ABA8E-E085-436D-A85F-34828E11C7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F1C0C68-EF8A-4757-8356-9A54C53E6B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292B109F-457C-4038-9D08-5FE5582C60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37D3C02-957F-4064-AE8C-42520CAB58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BD2F86A8-8F7B-4D07-A7AA-ACA6073D3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6CEF80B5-010E-46B1-8FB5-12E7907A3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15CA6BA-CCF6-4DA2-A7B1-A93B5C41F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6143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2E94FA6-2D37-4468-9EEE-E71888D181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ED6A35AF-55CB-4548-AD0E-ACB1AC09E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E27E8060-A706-4FD9-BB1E-DB6171B67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FC23B289-B2F9-4CBD-870D-56665C118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387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579AA97-C0AC-4E36-9DA2-BB7377501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EE767C9-2C53-499D-A7AB-AAB268100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796EB3B7-DCD5-43C4-929F-B362938D4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822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7E141A5-6ADE-4EDB-BE08-61A82BDA9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BEA4BCF-07DB-43EE-8079-0C0F2CF510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E43F692-81BF-4185-AB14-CA3AFB6D54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A41FF8B-A32F-48C1-B628-246D1C9B3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A998424-7F00-48EF-8574-0BF016DCF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5CC4FE1-E23E-48C5-96A5-9D99E90E8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599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6ED5946-975D-431E-830A-37F6665E59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CF73898A-1D9B-4DB7-862E-5D466BB525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DC303B6-51C7-486B-8AC1-832BF26637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04403F3-B5FD-4EE7-9B77-152936775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63649A7-4537-4291-887D-530B4711A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713758F-976F-452F-B940-65A02BD0B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50715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E80702B9-44C2-47CB-B61B-CC0E0A05E1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69B85E2-E3EF-4476-ADC0-203028DD1D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ABAA88F-0821-49BB-904B-1578E8295C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C0E61-D9C4-4B81-9BAB-8A74512D504D}" type="datetimeFigureOut">
              <a:rPr lang="en-GB" smtClean="0"/>
              <a:t>17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D63ACF7-243F-4EC6-B5B0-352F49537E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DC627D6-CA13-4A44-B25E-07E6002684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4A8FB-1435-4398-9C78-BDE13D5633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6492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6" name="Picture 14">
            <a:extLst>
              <a:ext uri="{FF2B5EF4-FFF2-40B4-BE49-F238E27FC236}">
                <a16:creationId xmlns:a16="http://schemas.microsoft.com/office/drawing/2014/main" xmlns="" id="{E8FC2D91-1881-4115-8323-1D2F528755C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2804" b="1370"/>
          <a:stretch/>
        </p:blipFill>
        <p:spPr bwMode="auto">
          <a:xfrm>
            <a:off x="2000729" y="1195875"/>
            <a:ext cx="3068916" cy="22717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>
            <a:extLst>
              <a:ext uri="{FF2B5EF4-FFF2-40B4-BE49-F238E27FC236}">
                <a16:creationId xmlns:a16="http://schemas.microsoft.com/office/drawing/2014/main" xmlns="" id="{6D3A807E-6232-420C-932F-D1897D5E4B7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6" t="1315" b="1363"/>
          <a:stretch/>
        </p:blipFill>
        <p:spPr bwMode="auto">
          <a:xfrm>
            <a:off x="2000729" y="3968375"/>
            <a:ext cx="3179298" cy="23983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1" name="Picture 9">
            <a:extLst>
              <a:ext uri="{FF2B5EF4-FFF2-40B4-BE49-F238E27FC236}">
                <a16:creationId xmlns:a16="http://schemas.microsoft.com/office/drawing/2014/main" xmlns="" id="{9E0E28F5-EBE2-4E71-990C-CF79DA79374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70"/>
          <a:stretch/>
        </p:blipFill>
        <p:spPr bwMode="auto">
          <a:xfrm>
            <a:off x="6329082" y="1187924"/>
            <a:ext cx="3067910" cy="25584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>
            <a:extLst>
              <a:ext uri="{FF2B5EF4-FFF2-40B4-BE49-F238E27FC236}">
                <a16:creationId xmlns:a16="http://schemas.microsoft.com/office/drawing/2014/main" xmlns="" id="{6E2E5B04-10DD-409C-8849-A6355E3D683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5" t="697" b="1403"/>
          <a:stretch/>
        </p:blipFill>
        <p:spPr bwMode="auto">
          <a:xfrm>
            <a:off x="6329082" y="3968376"/>
            <a:ext cx="2729858" cy="23324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1" name="Group 3">
            <a:extLst>
              <a:ext uri="{FF2B5EF4-FFF2-40B4-BE49-F238E27FC236}">
                <a16:creationId xmlns:a16="http://schemas.microsoft.com/office/drawing/2014/main" xmlns="" id="{C45DB27F-32AC-4813-896C-1007E5CCDF58}"/>
              </a:ext>
            </a:extLst>
          </p:cNvPr>
          <p:cNvGrpSpPr>
            <a:grpSpLocks/>
          </p:cNvGrpSpPr>
          <p:nvPr/>
        </p:nvGrpSpPr>
        <p:grpSpPr bwMode="auto">
          <a:xfrm>
            <a:off x="6391556" y="3570604"/>
            <a:ext cx="1277694" cy="226076"/>
            <a:chOff x="6142" y="-3595"/>
            <a:chExt cx="2012" cy="356"/>
          </a:xfrm>
        </p:grpSpPr>
        <p:sp>
          <p:nvSpPr>
            <p:cNvPr id="22" name="Freeform 4">
              <a:extLst>
                <a:ext uri="{FF2B5EF4-FFF2-40B4-BE49-F238E27FC236}">
                  <a16:creationId xmlns:a16="http://schemas.microsoft.com/office/drawing/2014/main" xmlns="" id="{6DA41DBE-6196-4A31-AA72-6A1371261372}"/>
                </a:ext>
              </a:extLst>
            </p:cNvPr>
            <p:cNvSpPr>
              <a:spLocks/>
            </p:cNvSpPr>
            <p:nvPr/>
          </p:nvSpPr>
          <p:spPr bwMode="auto">
            <a:xfrm>
              <a:off x="6142" y="-3595"/>
              <a:ext cx="2012" cy="356"/>
            </a:xfrm>
            <a:custGeom>
              <a:avLst/>
              <a:gdLst>
                <a:gd name="T0" fmla="+- 0 6142 6142"/>
                <a:gd name="T1" fmla="*/ T0 w 2012"/>
                <a:gd name="T2" fmla="+- 0 -3239 -3595"/>
                <a:gd name="T3" fmla="*/ -3239 h 356"/>
                <a:gd name="T4" fmla="+- 0 8153 6142"/>
                <a:gd name="T5" fmla="*/ T4 w 2012"/>
                <a:gd name="T6" fmla="+- 0 -3239 -3595"/>
                <a:gd name="T7" fmla="*/ -3239 h 356"/>
                <a:gd name="T8" fmla="+- 0 8153 6142"/>
                <a:gd name="T9" fmla="*/ T8 w 2012"/>
                <a:gd name="T10" fmla="+- 0 -3595 -3595"/>
                <a:gd name="T11" fmla="*/ -3595 h 356"/>
                <a:gd name="T12" fmla="+- 0 6142 6142"/>
                <a:gd name="T13" fmla="*/ T12 w 2012"/>
                <a:gd name="T14" fmla="+- 0 -3595 -3595"/>
                <a:gd name="T15" fmla="*/ -3595 h 356"/>
                <a:gd name="T16" fmla="+- 0 6142 6142"/>
                <a:gd name="T17" fmla="*/ T16 w 2012"/>
                <a:gd name="T18" fmla="+- 0 -3239 -3595"/>
                <a:gd name="T19" fmla="*/ -3239 h 356"/>
              </a:gdLst>
              <a:ahLst/>
              <a:cxnLst>
                <a:cxn ang="0">
                  <a:pos x="T1" y="T3"/>
                </a:cxn>
                <a:cxn ang="0">
                  <a:pos x="T5" y="T7"/>
                </a:cxn>
                <a:cxn ang="0">
                  <a:pos x="T9" y="T11"/>
                </a:cxn>
                <a:cxn ang="0">
                  <a:pos x="T13" y="T15"/>
                </a:cxn>
                <a:cxn ang="0">
                  <a:pos x="T17" y="T19"/>
                </a:cxn>
              </a:cxnLst>
              <a:rect l="0" t="0" r="r" b="b"/>
              <a:pathLst>
                <a:path w="2012" h="356">
                  <a:moveTo>
                    <a:pt x="0" y="356"/>
                  </a:moveTo>
                  <a:lnTo>
                    <a:pt x="2011" y="356"/>
                  </a:lnTo>
                  <a:lnTo>
                    <a:pt x="2011" y="0"/>
                  </a:lnTo>
                  <a:lnTo>
                    <a:pt x="0" y="0"/>
                  </a:lnTo>
                  <a:lnTo>
                    <a:pt x="0" y="356"/>
                  </a:ln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</p:grpSp>
      <p:sp>
        <p:nvSpPr>
          <p:cNvPr id="29" name="Rectangle 33">
            <a:extLst>
              <a:ext uri="{FF2B5EF4-FFF2-40B4-BE49-F238E27FC236}">
                <a16:creationId xmlns:a16="http://schemas.microsoft.com/office/drawing/2014/main" xmlns="" id="{F402B9A0-4052-4B86-9048-6D27644C7D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58650" y="3673361"/>
            <a:ext cx="207545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K3CA p.His1047Leu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34">
            <a:extLst>
              <a:ext uri="{FF2B5EF4-FFF2-40B4-BE49-F238E27FC236}">
                <a16:creationId xmlns:a16="http://schemas.microsoft.com/office/drawing/2014/main" xmlns="" id="{9D7D6D31-A532-4C5E-8717-45C080A9F8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31" name="Rectangle 35">
            <a:extLst>
              <a:ext uri="{FF2B5EF4-FFF2-40B4-BE49-F238E27FC236}">
                <a16:creationId xmlns:a16="http://schemas.microsoft.com/office/drawing/2014/main" xmlns="" id="{FEF7C276-BB55-40DB-BC44-24CC2A740C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6789" y="216769"/>
            <a:ext cx="1119306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ree-dimensional representation of selected examples of targetable variants. Mutation is shown in yellow, alpha-helix in orange and beta-sheets in blue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FE5EE06C-639C-41E4-8337-8DE5C6835F61}"/>
              </a:ext>
            </a:extLst>
          </p:cNvPr>
          <p:cNvSpPr txBox="1"/>
          <p:nvPr/>
        </p:nvSpPr>
        <p:spPr>
          <a:xfrm>
            <a:off x="1947189" y="966489"/>
            <a:ext cx="248194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RAF p.Val600Glu</a:t>
            </a:r>
            <a:r>
              <a:rPr lang="en-US" alt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GB" sz="12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9F45E3D3-E0C1-487A-9271-437438E88FFE}"/>
              </a:ext>
            </a:extLst>
          </p:cNvPr>
          <p:cNvSpPr txBox="1"/>
          <p:nvPr/>
        </p:nvSpPr>
        <p:spPr>
          <a:xfrm>
            <a:off x="1947189" y="3801236"/>
            <a:ext cx="16253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HEK2 p.Arg180Ter</a:t>
            </a:r>
            <a:r>
              <a:rPr lang="en-US" alt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GB" sz="12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87222182-CAA5-48BF-A823-2BCC4DAF2A14}"/>
              </a:ext>
            </a:extLst>
          </p:cNvPr>
          <p:cNvSpPr txBox="1"/>
          <p:nvPr/>
        </p:nvSpPr>
        <p:spPr>
          <a:xfrm>
            <a:off x="6540137" y="934278"/>
            <a:ext cx="26889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IK3CA p.Glu542Ly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723011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5</Words>
  <Application>Microsoft Office PowerPoint</Application>
  <PresentationFormat>Ευρεία οθόνη</PresentationFormat>
  <Paragraphs>5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Παρουσίαση του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ia Eliades</dc:creator>
  <cp:lastModifiedBy>Ioannis Kyrochristos</cp:lastModifiedBy>
  <cp:revision>2</cp:revision>
  <dcterms:created xsi:type="dcterms:W3CDTF">2022-02-17T07:07:29Z</dcterms:created>
  <dcterms:modified xsi:type="dcterms:W3CDTF">2022-02-17T10:46:07Z</dcterms:modified>
</cp:coreProperties>
</file>